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0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hesh\Desktop\BOST-D-16-00194-R1\wheatexp1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plotArea>
      <c:layout/>
      <c:barChart>
        <c:barDir val="col"/>
        <c:grouping val="clustered"/>
        <c:ser>
          <c:idx val="0"/>
          <c:order val="0"/>
          <c:errBars>
            <c:errBarType val="both"/>
            <c:errValType val="cust"/>
            <c:plus>
              <c:numRef>
                <c:f>'spike removal exp'!$T$27:$T$38</c:f>
                <c:numCache>
                  <c:formatCode>General</c:formatCode>
                  <c:ptCount val="12"/>
                  <c:pt idx="0">
                    <c:v>2.2549212994927577</c:v>
                  </c:pt>
                  <c:pt idx="1">
                    <c:v>2.1093612802818127</c:v>
                  </c:pt>
                  <c:pt idx="2">
                    <c:v>1.2105735631493832</c:v>
                  </c:pt>
                  <c:pt idx="3">
                    <c:v>0.90968958807520273</c:v>
                  </c:pt>
                  <c:pt idx="4">
                    <c:v>0.83656794886062058</c:v>
                  </c:pt>
                  <c:pt idx="5">
                    <c:v>6.4284532671629053</c:v>
                  </c:pt>
                  <c:pt idx="6">
                    <c:v>1.8243258392208099</c:v>
                  </c:pt>
                  <c:pt idx="7">
                    <c:v>0.44428152492653139</c:v>
                  </c:pt>
                  <c:pt idx="8">
                    <c:v>1.9255023973872538</c:v>
                  </c:pt>
                  <c:pt idx="9">
                    <c:v>2.1222730041113631</c:v>
                  </c:pt>
                  <c:pt idx="10">
                    <c:v>1.4231454552081964</c:v>
                  </c:pt>
                  <c:pt idx="11">
                    <c:v>2.3168690322324621</c:v>
                  </c:pt>
                </c:numCache>
              </c:numRef>
            </c:plus>
            <c:minus>
              <c:numRef>
                <c:f>'spike removal exp'!$T$27:$T$38</c:f>
                <c:numCache>
                  <c:formatCode>General</c:formatCode>
                  <c:ptCount val="12"/>
                  <c:pt idx="0">
                    <c:v>2.2549212994927577</c:v>
                  </c:pt>
                  <c:pt idx="1">
                    <c:v>2.1093612802818127</c:v>
                  </c:pt>
                  <c:pt idx="2">
                    <c:v>1.2105735631493832</c:v>
                  </c:pt>
                  <c:pt idx="3">
                    <c:v>0.90968958807520273</c:v>
                  </c:pt>
                  <c:pt idx="4">
                    <c:v>0.83656794886062058</c:v>
                  </c:pt>
                  <c:pt idx="5">
                    <c:v>6.4284532671629053</c:v>
                  </c:pt>
                  <c:pt idx="6">
                    <c:v>1.8243258392208099</c:v>
                  </c:pt>
                  <c:pt idx="7">
                    <c:v>0.44428152492653139</c:v>
                  </c:pt>
                  <c:pt idx="8">
                    <c:v>1.9255023973872538</c:v>
                  </c:pt>
                  <c:pt idx="9">
                    <c:v>2.1222730041113631</c:v>
                  </c:pt>
                  <c:pt idx="10">
                    <c:v>1.4231454552081964</c:v>
                  </c:pt>
                  <c:pt idx="11">
                    <c:v>2.3168690322324621</c:v>
                  </c:pt>
                </c:numCache>
              </c:numRef>
            </c:minus>
          </c:errBars>
          <c:cat>
            <c:multiLvlStrRef>
              <c:f>'spike removal exp'!$Q$27:$R$38</c:f>
              <c:multiLvlStrCache>
                <c:ptCount val="12"/>
                <c:lvl>
                  <c:pt idx="0">
                    <c:v>HD-2189</c:v>
                  </c:pt>
                  <c:pt idx="1">
                    <c:v>LOK-1</c:v>
                  </c:pt>
                  <c:pt idx="2">
                    <c:v>NIAW-301</c:v>
                  </c:pt>
                  <c:pt idx="3">
                    <c:v>NIAW-34</c:v>
                  </c:pt>
                  <c:pt idx="4">
                    <c:v>HD-2189</c:v>
                  </c:pt>
                  <c:pt idx="5">
                    <c:v>LOK-1</c:v>
                  </c:pt>
                  <c:pt idx="6">
                    <c:v>NIAW-301</c:v>
                  </c:pt>
                  <c:pt idx="7">
                    <c:v>NIAW-34</c:v>
                  </c:pt>
                  <c:pt idx="8">
                    <c:v>HD-2189</c:v>
                  </c:pt>
                  <c:pt idx="9">
                    <c:v>LOK-1</c:v>
                  </c:pt>
                  <c:pt idx="10">
                    <c:v>NIAW-301</c:v>
                  </c:pt>
                  <c:pt idx="11">
                    <c:v>NIAW-34</c:v>
                  </c:pt>
                </c:lvl>
                <c:lvl>
                  <c:pt idx="0">
                    <c:v>15-30</c:v>
                  </c:pt>
                  <c:pt idx="4">
                    <c:v>31-45</c:v>
                  </c:pt>
                  <c:pt idx="8">
                    <c:v>&gt;45</c:v>
                  </c:pt>
                </c:lvl>
              </c:multiLvlStrCache>
            </c:multiLvlStrRef>
          </c:cat>
          <c:val>
            <c:numRef>
              <c:f>'spike removal exp'!$S$27:$S$38</c:f>
              <c:numCache>
                <c:formatCode>0.00</c:formatCode>
                <c:ptCount val="12"/>
                <c:pt idx="0">
                  <c:v>39.426023351960374</c:v>
                </c:pt>
                <c:pt idx="1">
                  <c:v>52.941047639445571</c:v>
                </c:pt>
                <c:pt idx="2">
                  <c:v>46.116083889272289</c:v>
                </c:pt>
                <c:pt idx="3">
                  <c:v>45.851152583049128</c:v>
                </c:pt>
                <c:pt idx="4">
                  <c:v>44.6949484767025</c:v>
                </c:pt>
                <c:pt idx="5">
                  <c:v>53.248966087675768</c:v>
                </c:pt>
                <c:pt idx="6">
                  <c:v>45.775017806267812</c:v>
                </c:pt>
                <c:pt idx="7">
                  <c:v>48.282991202346032</c:v>
                </c:pt>
                <c:pt idx="8">
                  <c:v>39.476152837910114</c:v>
                </c:pt>
                <c:pt idx="9">
                  <c:v>52.752077278623055</c:v>
                </c:pt>
                <c:pt idx="10">
                  <c:v>42.098011778570736</c:v>
                </c:pt>
                <c:pt idx="11">
                  <c:v>40.130562106505522</c:v>
                </c:pt>
              </c:numCache>
            </c:numRef>
          </c:val>
        </c:ser>
        <c:dLbls/>
        <c:axId val="75143808"/>
        <c:axId val="78275328"/>
      </c:barChart>
      <c:catAx>
        <c:axId val="7514380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Grain nomber per spike</a:t>
                </a:r>
              </a:p>
            </c:rich>
          </c:tx>
          <c:layout/>
        </c:title>
        <c:numFmt formatCode="General" sourceLinked="1"/>
        <c:tickLblPos val="nextTo"/>
        <c:crossAx val="78275328"/>
        <c:crosses val="autoZero"/>
        <c:auto val="1"/>
        <c:lblAlgn val="ctr"/>
        <c:lblOffset val="100"/>
      </c:catAx>
      <c:valAx>
        <c:axId val="7827532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ingle grain weight (mg)</a:t>
                </a:r>
              </a:p>
            </c:rich>
          </c:tx>
          <c:layout/>
        </c:title>
        <c:numFmt formatCode="0" sourceLinked="0"/>
        <c:tickLblPos val="nextTo"/>
        <c:crossAx val="75143808"/>
        <c:crosses val="autoZero"/>
        <c:crossBetween val="between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B747A2-85F4-4D25-81E1-8E311143A774}" type="datetimeFigureOut">
              <a:rPr lang="en-IN" smtClean="0"/>
              <a:pPr/>
              <a:t>09-03-2017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7783E7-B663-45EF-818F-F63DC3745DE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29298046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just"/>
            <a:r>
              <a:rPr lang="en-IN" sz="1200" b="1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S3: </a:t>
            </a:r>
            <a:r>
              <a:rPr lang="en-IN" sz="1200" b="1" dirty="0">
                <a:latin typeface="Times New Roman" pitchFamily="18" charset="0"/>
                <a:cs typeface="Times New Roman" pitchFamily="18" charset="0"/>
              </a:rPr>
              <a:t>Final SGW (at physiological maturity) of four wheat genotypes at varying range of grains retained on each spike at the time of anthesis. Error bars derived from 6 to 8 observations. Means with same letter are not significantly different at p&lt;0.05</a:t>
            </a:r>
          </a:p>
        </p:txBody>
      </p:sp>
      <p:graphicFrame>
        <p:nvGraphicFramePr>
          <p:cNvPr id="7" name="Content Placeholder 6"/>
          <p:cNvGraphicFramePr>
            <a:graphicFrameLocks noGrp="1"/>
          </p:cNvGraphicFramePr>
          <p:nvPr>
            <p:ph idx="1"/>
          </p:nvPr>
        </p:nvGraphicFramePr>
        <p:xfrm>
          <a:off x="457200" y="1600200"/>
          <a:ext cx="8229600" cy="452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752600" y="2223016"/>
            <a:ext cx="457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900" dirty="0" smtClean="0"/>
              <a:t>a</a:t>
            </a:r>
            <a:endParaRPr lang="en-IN" sz="900" dirty="0"/>
          </a:p>
        </p:txBody>
      </p:sp>
      <p:sp>
        <p:nvSpPr>
          <p:cNvPr id="9" name="TextBox 8"/>
          <p:cNvSpPr txBox="1"/>
          <p:nvPr/>
        </p:nvSpPr>
        <p:spPr>
          <a:xfrm>
            <a:off x="2514600" y="2667000"/>
            <a:ext cx="381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 smtClean="0"/>
              <a:t>b</a:t>
            </a:r>
            <a:endParaRPr lang="en-IN" sz="900" dirty="0"/>
          </a:p>
        </p:txBody>
      </p:sp>
      <p:sp>
        <p:nvSpPr>
          <p:cNvPr id="10" name="TextBox 9"/>
          <p:cNvSpPr txBox="1"/>
          <p:nvPr/>
        </p:nvSpPr>
        <p:spPr>
          <a:xfrm>
            <a:off x="3124200" y="2667000"/>
            <a:ext cx="381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 smtClean="0"/>
              <a:t>b</a:t>
            </a:r>
            <a:endParaRPr lang="en-IN" sz="900" dirty="0"/>
          </a:p>
        </p:txBody>
      </p:sp>
      <p:sp>
        <p:nvSpPr>
          <p:cNvPr id="11" name="TextBox 10"/>
          <p:cNvSpPr txBox="1"/>
          <p:nvPr/>
        </p:nvSpPr>
        <p:spPr>
          <a:xfrm>
            <a:off x="1143000" y="2893368"/>
            <a:ext cx="457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900" dirty="0" smtClean="0"/>
              <a:t>c</a:t>
            </a:r>
            <a:endParaRPr lang="en-IN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4267200" y="1981200"/>
            <a:ext cx="457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900" dirty="0" smtClean="0"/>
              <a:t>a</a:t>
            </a:r>
            <a:endParaRPr lang="en-IN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4953000" y="2590800"/>
            <a:ext cx="381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 err="1" smtClean="0"/>
              <a:t>bc</a:t>
            </a:r>
            <a:endParaRPr lang="en-IN" sz="900" dirty="0"/>
          </a:p>
        </p:txBody>
      </p:sp>
      <p:sp>
        <p:nvSpPr>
          <p:cNvPr id="14" name="TextBox 13"/>
          <p:cNvSpPr txBox="1"/>
          <p:nvPr/>
        </p:nvSpPr>
        <p:spPr>
          <a:xfrm>
            <a:off x="5562600" y="2575352"/>
            <a:ext cx="381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900" dirty="0" smtClean="0"/>
              <a:t>b</a:t>
            </a:r>
            <a:endParaRPr lang="en-IN" sz="900" dirty="0"/>
          </a:p>
        </p:txBody>
      </p:sp>
      <p:sp>
        <p:nvSpPr>
          <p:cNvPr id="15" name="TextBox 14"/>
          <p:cNvSpPr txBox="1"/>
          <p:nvPr/>
        </p:nvSpPr>
        <p:spPr>
          <a:xfrm>
            <a:off x="3657600" y="2669232"/>
            <a:ext cx="381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900" dirty="0" err="1" smtClean="0"/>
              <a:t>bc</a:t>
            </a:r>
            <a:endParaRPr lang="en-IN" sz="900" dirty="0"/>
          </a:p>
        </p:txBody>
      </p:sp>
      <p:sp>
        <p:nvSpPr>
          <p:cNvPr id="16" name="TextBox 15"/>
          <p:cNvSpPr txBox="1"/>
          <p:nvPr/>
        </p:nvSpPr>
        <p:spPr>
          <a:xfrm>
            <a:off x="6858000" y="2207568"/>
            <a:ext cx="381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 smtClean="0"/>
              <a:t>a</a:t>
            </a:r>
            <a:endParaRPr lang="en-IN" sz="900" dirty="0"/>
          </a:p>
        </p:txBody>
      </p:sp>
      <p:sp>
        <p:nvSpPr>
          <p:cNvPr id="17" name="TextBox 16"/>
          <p:cNvSpPr txBox="1"/>
          <p:nvPr/>
        </p:nvSpPr>
        <p:spPr>
          <a:xfrm>
            <a:off x="7467600" y="2819400"/>
            <a:ext cx="381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 smtClean="0"/>
              <a:t>c</a:t>
            </a:r>
            <a:endParaRPr lang="en-IN" sz="900" dirty="0"/>
          </a:p>
        </p:txBody>
      </p:sp>
      <p:sp>
        <p:nvSpPr>
          <p:cNvPr id="18" name="TextBox 17"/>
          <p:cNvSpPr txBox="1"/>
          <p:nvPr/>
        </p:nvSpPr>
        <p:spPr>
          <a:xfrm>
            <a:off x="8001000" y="2893368"/>
            <a:ext cx="457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900" dirty="0" smtClean="0"/>
              <a:t>c</a:t>
            </a:r>
            <a:endParaRPr lang="en-IN" sz="900" dirty="0"/>
          </a:p>
        </p:txBody>
      </p:sp>
      <p:sp>
        <p:nvSpPr>
          <p:cNvPr id="19" name="TextBox 18"/>
          <p:cNvSpPr txBox="1"/>
          <p:nvPr/>
        </p:nvSpPr>
        <p:spPr>
          <a:xfrm>
            <a:off x="6248400" y="2969568"/>
            <a:ext cx="381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 smtClean="0"/>
              <a:t>c</a:t>
            </a:r>
            <a:endParaRPr lang="en-IN" sz="900" dirty="0"/>
          </a:p>
        </p:txBody>
      </p:sp>
    </p:spTree>
    <p:extLst>
      <p:ext uri="{BB962C8B-B14F-4D97-AF65-F5344CB8AC3E}">
        <p14:creationId xmlns:p14="http://schemas.microsoft.com/office/powerpoint/2010/main" xmlns="" val="24108104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0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Table S3: Final SGW (at physiological maturity) of four wheat genotypes at varying range of grains retained on each spike at the time of anthesis. Error bars derived from 6 to 8 observations. Means with same letter are not significantly different at p&lt;0.05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3</dc:title>
  <dc:creator>Mahesh</dc:creator>
  <cp:lastModifiedBy>0011687</cp:lastModifiedBy>
  <cp:revision>4</cp:revision>
  <dcterms:created xsi:type="dcterms:W3CDTF">2006-08-16T00:00:00Z</dcterms:created>
  <dcterms:modified xsi:type="dcterms:W3CDTF">2017-03-09T15:35:13Z</dcterms:modified>
</cp:coreProperties>
</file>